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7" r:id="rId2"/>
    <p:sldId id="266" r:id="rId3"/>
    <p:sldId id="258" r:id="rId4"/>
    <p:sldId id="261" r:id="rId5"/>
    <p:sldId id="262" r:id="rId6"/>
    <p:sldId id="263" r:id="rId7"/>
    <p:sldId id="259" r:id="rId8"/>
    <p:sldId id="265" r:id="rId9"/>
    <p:sldId id="268" r:id="rId10"/>
    <p:sldId id="264" r:id="rId11"/>
    <p:sldId id="269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5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A3AF58-F555-482A-82C5-6C1DC4D8AC3B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D07543-5D58-4316-A645-C5914F70A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573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D07543-5D58-4316-A645-C5914F70ADE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342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19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366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174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636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994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099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448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256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84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758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345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2093E-DDFB-4630-A2F1-8CCC6478426E}" type="datetimeFigureOut">
              <a:rPr lang="en-US" smtClean="0"/>
              <a:t>12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4FFDC-6B33-44D2-85A9-FE2173C46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432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66800" y="15240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1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331" y="1952625"/>
            <a:ext cx="6951663" cy="2543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12865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997200" y="1625600"/>
            <a:ext cx="3136900" cy="3606800"/>
            <a:chOff x="2997200" y="1625600"/>
            <a:chExt cx="3136900" cy="36068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97200" y="1625600"/>
              <a:ext cx="3136900" cy="36068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124200" y="19050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S10</a:t>
              </a:r>
              <a:endParaRPr lang="en-US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190001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029163" y="1503581"/>
            <a:ext cx="637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11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4" name="Group 15"/>
          <p:cNvGrpSpPr/>
          <p:nvPr/>
        </p:nvGrpSpPr>
        <p:grpSpPr>
          <a:xfrm>
            <a:off x="2866855" y="1169649"/>
            <a:ext cx="1818621" cy="3095382"/>
            <a:chOff x="3657600" y="1784395"/>
            <a:chExt cx="1818621" cy="3095382"/>
          </a:xfrm>
        </p:grpSpPr>
        <p:pic>
          <p:nvPicPr>
            <p:cNvPr id="5" name="Picture 4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2476" y="3675888"/>
              <a:ext cx="914400" cy="3657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6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88506" y="3259014"/>
              <a:ext cx="914400" cy="3657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8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2476" y="4498848"/>
              <a:ext cx="914400" cy="3657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3960526" y="2284025"/>
              <a:ext cx="15224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siRNA </a:t>
              </a:r>
              <a:endParaRPr lang="en-US" sz="1400" b="1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4852973" y="2679597"/>
              <a:ext cx="72327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Ezrin </a:t>
              </a:r>
              <a:endParaRPr lang="en-US" sz="1400" b="1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siRNA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881883" y="3703320"/>
              <a:ext cx="914400" cy="365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XIAP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657600" y="4572000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867594" y="3276600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e</a:t>
              </a:r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zrin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3" name="Picture 2"/>
            <p:cNvPicPr preferRelativeResize="0">
              <a:picLocks noChangeArrowheads="1"/>
            </p:cNvPicPr>
            <p:nvPr/>
          </p:nvPicPr>
          <p:blipFill>
            <a:blip r:embed="rId5" cstate="print">
              <a:lum bright="-10000" contrast="40000"/>
            </a:blip>
            <a:srcRect/>
            <a:stretch>
              <a:fillRect/>
            </a:stretch>
          </p:blipFill>
          <p:spPr bwMode="auto">
            <a:xfrm>
              <a:off x="4495800" y="4087368"/>
              <a:ext cx="914400" cy="3657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3657600" y="4114800"/>
              <a:ext cx="8707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survivin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623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8184" y="1901383"/>
            <a:ext cx="3782616" cy="259441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029163" y="1503581"/>
            <a:ext cx="496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2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64360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8325" y="2209800"/>
            <a:ext cx="5467350" cy="2228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029163" y="1503581"/>
            <a:ext cx="496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3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04285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1200" y="1612900"/>
            <a:ext cx="5181600" cy="36322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029163" y="1503581"/>
            <a:ext cx="496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4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95516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7105" y="1447800"/>
            <a:ext cx="4498495" cy="3429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33600" y="1143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  <a:cs typeface="Arial"/>
              </a:rPr>
              <a:t>S5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36970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8506" y="1828800"/>
            <a:ext cx="3502188" cy="23622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438400" y="15240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6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97229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8400" y="2057400"/>
            <a:ext cx="4406900" cy="22098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029163" y="1503581"/>
            <a:ext cx="496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7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309624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057400" y="1066800"/>
            <a:ext cx="685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8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0813" y="1190625"/>
            <a:ext cx="3762375" cy="4476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57478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688" y="1771650"/>
            <a:ext cx="8047037" cy="3314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990600" y="1503581"/>
            <a:ext cx="496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9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12436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20</Words>
  <Application>Microsoft Office PowerPoint</Application>
  <PresentationFormat>On-screen Show (4:3)</PresentationFormat>
  <Paragraphs>20</Paragraphs>
  <Slides>1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jib Chowdhury</dc:creator>
  <cp:lastModifiedBy>Sanjib Chowdhury</cp:lastModifiedBy>
  <cp:revision>19</cp:revision>
  <dcterms:created xsi:type="dcterms:W3CDTF">2013-06-27T17:52:09Z</dcterms:created>
  <dcterms:modified xsi:type="dcterms:W3CDTF">2013-12-26T22:18:47Z</dcterms:modified>
</cp:coreProperties>
</file>